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612421-14A5-4776-93A7-68462A96FA4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DA8602-38A5-49B4-953B-DD93AA2D510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45112-314D-4412-822F-5D9F89B4EF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59A92-7C7E-4418-AD50-5D0FC598E3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55B4D-34D5-4C7F-8718-8FACC60509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9E5DE-0239-470E-9D66-4DBBE490DC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3ADBB-839D-4339-85E9-2D8A292956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DF7B9-A60E-4CBC-9D39-9812B82102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6B526-3432-4E11-927C-7C283F961E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58655-0371-4182-89E6-33B3757826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B98B6-EC56-49CC-A6BB-2E3C6E961A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79D28-4448-4495-9A3C-3D296D8690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C7613-DA11-4736-B84E-6D3C0D600E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51770-C35A-4866-B257-D97F69BE15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4763AA-EA88-4BC7-9774-81BE343AE5D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1"/>
          <p:cNvGrpSpPr/>
          <p:nvPr/>
        </p:nvGrpSpPr>
        <p:grpSpPr>
          <a:xfrm>
            <a:off x="457200" y="228600"/>
            <a:ext cx="4800600" cy="4896000"/>
            <a:chOff x="457200" y="228600"/>
            <a:chExt cx="4800600" cy="4896000"/>
          </a:xfrm>
        </p:grpSpPr>
        <p:pic>
          <p:nvPicPr>
            <p:cNvPr id="49" name="Picture 4" descr="Supplemental Figure"/>
            <p:cNvPicPr/>
            <p:nvPr/>
          </p:nvPicPr>
          <p:blipFill>
            <a:blip r:embed="rId1"/>
            <a:stretch/>
          </p:blipFill>
          <p:spPr>
            <a:xfrm>
              <a:off x="457200" y="228600"/>
              <a:ext cx="4800600" cy="489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 Box 5"/>
            <p:cNvSpPr/>
            <p:nvPr/>
          </p:nvSpPr>
          <p:spPr>
            <a:xfrm>
              <a:off x="2133720" y="2286000"/>
              <a:ext cx="6858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LV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6"/>
            <p:cNvSpPr/>
            <p:nvPr/>
          </p:nvSpPr>
          <p:spPr>
            <a:xfrm>
              <a:off x="1066680" y="3657600"/>
              <a:ext cx="6858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RV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7"/>
            <p:cNvSpPr/>
            <p:nvPr/>
          </p:nvSpPr>
          <p:spPr>
            <a:xfrm flipV="1">
              <a:off x="3962520" y="1752480"/>
              <a:ext cx="457200" cy="228600"/>
            </a:xfrm>
            <a:prstGeom prst="line">
              <a:avLst/>
            </a:prstGeom>
            <a:ln w="5076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8"/>
            <p:cNvSpPr/>
            <p:nvPr/>
          </p:nvSpPr>
          <p:spPr>
            <a:xfrm flipH="1">
              <a:off x="4572000" y="1447920"/>
              <a:ext cx="457200" cy="228600"/>
            </a:xfrm>
            <a:prstGeom prst="line">
              <a:avLst/>
            </a:prstGeom>
            <a:ln w="5076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9"/>
            <p:cNvSpPr/>
            <p:nvPr/>
          </p:nvSpPr>
          <p:spPr>
            <a:xfrm flipV="1">
              <a:off x="4800600" y="3124080"/>
              <a:ext cx="0" cy="609480"/>
            </a:xfrm>
            <a:prstGeom prst="line">
              <a:avLst/>
            </a:prstGeom>
            <a:ln w="50760">
              <a:solidFill>
                <a:srgbClr val="00ff00"/>
              </a:solidFill>
              <a:prstDash val="sysDot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Text Box 12"/>
          <p:cNvSpPr/>
          <p:nvPr/>
        </p:nvSpPr>
        <p:spPr>
          <a:xfrm>
            <a:off x="609480" y="5334120"/>
            <a:ext cx="80773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Supplementary Figure S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True-FISP image from the patient depicted in Figure 3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  Solid arrows delineate compacted myocardium.  Dashed arrow indicates epicardial fat.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LV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left ventricle;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V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right ventricle.  Systolic function can be viewed in the Supplementary Movi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 Box 2"/>
          <p:cNvSpPr/>
          <p:nvPr/>
        </p:nvSpPr>
        <p:spPr>
          <a:xfrm>
            <a:off x="4419720" y="3886200"/>
            <a:ext cx="441936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Supplementary Figure S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.  </a:t>
            </a:r>
            <a:r>
              <a:rPr b="0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Interobserver variability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  Signal intensity, used to determine presence or absence of LGE.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  Maximum NC:C layer thickness ratio.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  Left ventricular end-diastolic volume (LVEDV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4419720" y="228600"/>
            <a:ext cx="3533760" cy="32925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4" descr=""/>
          <p:cNvPicPr/>
          <p:nvPr/>
        </p:nvPicPr>
        <p:blipFill>
          <a:blip r:embed="rId2"/>
          <a:stretch/>
        </p:blipFill>
        <p:spPr>
          <a:xfrm>
            <a:off x="457200" y="609480"/>
            <a:ext cx="3962520" cy="2781360"/>
          </a:xfrm>
          <a:prstGeom prst="rect">
            <a:avLst/>
          </a:prstGeom>
          <a:ln w="0">
            <a:noFill/>
          </a:ln>
        </p:spPr>
      </p:pic>
      <p:sp>
        <p:nvSpPr>
          <p:cNvPr id="59" name="TextBox 8"/>
          <p:cNvSpPr/>
          <p:nvPr/>
        </p:nvSpPr>
        <p:spPr>
          <a:xfrm>
            <a:off x="457200" y="228600"/>
            <a:ext cx="2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3" descr=""/>
          <p:cNvPicPr/>
          <p:nvPr/>
        </p:nvPicPr>
        <p:blipFill>
          <a:blip r:embed="rId3"/>
          <a:stretch/>
        </p:blipFill>
        <p:spPr>
          <a:xfrm>
            <a:off x="762120" y="3581280"/>
            <a:ext cx="3657600" cy="3013200"/>
          </a:xfrm>
          <a:prstGeom prst="rect">
            <a:avLst/>
          </a:prstGeom>
          <a:ln w="0">
            <a:noFill/>
          </a:ln>
        </p:spPr>
      </p:pic>
      <p:sp>
        <p:nvSpPr>
          <p:cNvPr id="61" name="TextBox 8"/>
          <p:cNvSpPr/>
          <p:nvPr/>
        </p:nvSpPr>
        <p:spPr>
          <a:xfrm>
            <a:off x="685800" y="3276720"/>
            <a:ext cx="2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8"/>
          <p:cNvSpPr/>
          <p:nvPr/>
        </p:nvSpPr>
        <p:spPr>
          <a:xfrm>
            <a:off x="4495680" y="228600"/>
            <a:ext cx="2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30T03:11:22Z</dcterms:created>
  <dc:creator>weissr</dc:creator>
  <dc:description/>
  <dc:language>en-US</dc:language>
  <cp:lastModifiedBy>Ashrith, Guha M.D.</cp:lastModifiedBy>
  <dcterms:modified xsi:type="dcterms:W3CDTF">2014-04-21T15:12:30Z</dcterms:modified>
  <cp:revision>2</cp:revision>
  <dc:subject/>
  <dc:title>Slide 1</dc:title>
</cp:coreProperties>
</file>